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05" r:id="rId2"/>
    <p:sldId id="403" r:id="rId3"/>
    <p:sldId id="404" r:id="rId4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63"/>
  </p:normalViewPr>
  <p:slideViewPr>
    <p:cSldViewPr snapToGrid="0">
      <p:cViewPr varScale="1">
        <p:scale>
          <a:sx n="117" d="100"/>
          <a:sy n="117" d="100"/>
        </p:scale>
        <p:origin x="1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C36C2-0263-8C89-F80F-E82EC45516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645734-C818-BD4B-06F4-7B9D6A8CDC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358102-0114-90B0-81BB-3F9BEDF00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7EDBED-CFC7-9EEE-E279-C00D00AEE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F62324-B6C8-602C-25C8-53F091DB0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2052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91296D-B4FD-6B66-6A11-B8ACEA8951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B2664E-4BA1-B09D-C69F-C9E098E296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3AE636-2B00-C03E-0063-6279C2EE0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EE4FB8-1381-CA83-F369-85F8AF4B7D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04E06F-A4BC-E7F7-5265-ABA4F4C3C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7138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774DB3-933E-44A6-FA48-C974CBF2F4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0843A3-68C5-1143-E08D-F9FB76BA7B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588A6A-3A4E-7C90-A6B2-E63FB39CA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F78B87-C738-0D1B-5D69-2636CDEFC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63EBCA-C482-7358-63BA-E41B5AE50F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10794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146976-D62E-B2FC-3598-3BDE54CA71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E6641B-FEBB-2357-56CB-EBA1D63AE0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935DE5-2354-01A5-BF3F-B802948FC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4DEEF7-8A8B-C906-48F0-502DE1D8C0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8080D1-7A4A-9B5A-5EC4-32364C85D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496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2A3EC-C588-BD5E-AF4B-C7C6E75A8E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FE44F0-DE86-CCC8-0A08-C63FB51A7C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E60741-8EE2-4F5C-FE3D-C56E864E0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9D4275-A9DB-7C75-E4DD-721D2EEE7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2A78BB-3F6C-1A64-D8C1-95015E34C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628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C7A829-92C1-033D-AAB2-C8A1CF0546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654E12-8062-E89F-7E4D-40B8FDD5A3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3BB43F-38A3-8383-10FF-EFB8B6BF4C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8AA572-7E57-2E90-9B6E-C1200BECB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F37256-26AB-7108-5DE1-8D5A1CA73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15DBAB-60C7-B16E-3648-BA2B036B7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2570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8CA3E6-9384-06E7-F4AD-725F025A55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6E7B99-66C1-5687-09F4-ECA323F2C9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BAB9EA-3A73-1906-83E0-5A68C965C5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32CBAB0-CA0F-D114-373B-680C194777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CB1C0D-B830-444C-EDD3-D21C17A1F4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071D85A-6934-BA7E-96A6-FF29FC207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4C9C8E-E43F-0E9C-3434-28CCB37F9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90CBAC-05C8-66D2-3DB5-AEA6F2D90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1558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0A12A5-16D6-FDC7-D963-F2087185F2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8C40A7-63E4-618E-3188-799CB8EFB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03A58E-77ED-4672-BDAA-F6C594778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33B53E-1F9D-0F3C-91A6-AB2A0D052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4337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45A67C-4FBA-E3B1-D2DB-8C4621F3D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265BA01-99A5-B825-5ECB-510C6A3B9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94D361-F529-10CB-8181-92F860C36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78150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261D2-7B15-E186-BFB0-6EDC2ADF89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58FE14-775F-DEC0-BC15-B017B7894C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BCDB8E-EC42-4BFE-D89A-43A367932D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9A0DE0-CCA4-0C54-A9CB-6D33BED53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2A5582-59BD-F296-F327-480D258CB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1F5B27-9375-97C7-92E8-9C6FCDE6C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9633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1503C-C632-C89F-7853-C26071AD7B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699AE2-7184-FB3F-D290-3965E66A13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56B2C9-938D-876A-DD27-61C41F8E10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E30533-FAD4-86D0-0B72-6768CE0D9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C45899-E46B-4319-88A8-7692E3187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F75882-8791-0FDF-FFB4-A53D2C658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46760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19BEBB-8370-EA50-A9F3-5BD4F83C6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C9E655-2E07-0067-36EC-D79F1E443E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F30EDB-BD88-F006-0D43-E0FCE5D6A2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1CE133-0F84-4D38-AAE7-E8866E04F680}" type="datetimeFigureOut">
              <a:rPr lang="it-IT" smtClean="0"/>
              <a:t>12/08/25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52018B-D69C-DC78-A090-D89997BD5A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2A81EC-7D24-5FB1-09CB-95F0070360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02F599-7246-43D7-8A07-30BAEC6E527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6836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oup of test tubes with different colored liquid&#10;&#10;AI-generated content may be incorrect.">
            <a:extLst>
              <a:ext uri="{FF2B5EF4-FFF2-40B4-BE49-F238E27FC236}">
                <a16:creationId xmlns:a16="http://schemas.microsoft.com/office/drawing/2014/main" id="{BF410411-0038-30E4-A52B-66E51D2B7F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2" t="24654" r="18460" b="9168"/>
          <a:stretch>
            <a:fillRect/>
          </a:stretch>
        </p:blipFill>
        <p:spPr>
          <a:xfrm>
            <a:off x="550606" y="2915265"/>
            <a:ext cx="3056040" cy="2349910"/>
          </a:xfrm>
          <a:prstGeom prst="rect">
            <a:avLst/>
          </a:prstGeom>
        </p:spPr>
      </p:pic>
      <p:pic>
        <p:nvPicPr>
          <p:cNvPr id="7" name="Picture 6" descr="A group of test tubes with liquid in them&#10;&#10;AI-generated content may be incorrect.">
            <a:extLst>
              <a:ext uri="{FF2B5EF4-FFF2-40B4-BE49-F238E27FC236}">
                <a16:creationId xmlns:a16="http://schemas.microsoft.com/office/drawing/2014/main" id="{63D050B1-7768-A28D-EFE6-3CE11013F93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39" t="23961" r="26895" b="28443"/>
          <a:stretch>
            <a:fillRect/>
          </a:stretch>
        </p:blipFill>
        <p:spPr>
          <a:xfrm>
            <a:off x="550606" y="542227"/>
            <a:ext cx="3056040" cy="226488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CED4329-A5B3-CA68-6A58-0C09615CA075}"/>
              </a:ext>
            </a:extLst>
          </p:cNvPr>
          <p:cNvSpPr txBox="1"/>
          <p:nvPr/>
        </p:nvSpPr>
        <p:spPr>
          <a:xfrm>
            <a:off x="188778" y="5467240"/>
            <a:ext cx="856979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it-IT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antabrica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tracts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vents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gital images of </a:t>
            </a:r>
            <a:r>
              <a:rPr lang="it-IT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glena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tract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ubating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eeze-dri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uglena (2 mg) for 1 h o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c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vent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low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ntrifugatio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000 g for 15 min. The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vent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CA 50 % (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/v),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thanol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xane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orbance at 750 nm measured after Folin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ocalteu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ay performed on 30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ach extract. 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84CD5FA-5605-1F64-54B8-58529F9DC0CE}"/>
              </a:ext>
            </a:extLst>
          </p:cNvPr>
          <p:cNvSpPr txBox="1"/>
          <p:nvPr/>
        </p:nvSpPr>
        <p:spPr>
          <a:xfrm>
            <a:off x="904948" y="172895"/>
            <a:ext cx="60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TC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FB2548A-EF65-FEEB-96A5-3C809C3B1E95}"/>
              </a:ext>
            </a:extLst>
          </p:cNvPr>
          <p:cNvSpPr txBox="1"/>
          <p:nvPr/>
        </p:nvSpPr>
        <p:spPr>
          <a:xfrm>
            <a:off x="1818402" y="172895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EtOH</a:t>
            </a:r>
            <a:endParaRPr lang="it-IT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0B8310C-8D90-ED32-BB54-76F1EE474DFA}"/>
              </a:ext>
            </a:extLst>
          </p:cNvPr>
          <p:cNvSpPr txBox="1"/>
          <p:nvPr/>
        </p:nvSpPr>
        <p:spPr>
          <a:xfrm>
            <a:off x="2712524" y="172895"/>
            <a:ext cx="942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hexane</a:t>
            </a:r>
            <a:endParaRPr lang="it-IT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003C66B-40EA-3772-320E-FCD31B606FFA}"/>
              </a:ext>
            </a:extLst>
          </p:cNvPr>
          <p:cNvSpPr txBox="1"/>
          <p:nvPr/>
        </p:nvSpPr>
        <p:spPr>
          <a:xfrm>
            <a:off x="47088" y="-29170"/>
            <a:ext cx="6764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8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endParaRPr lang="it-IT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CBDB11A-94AF-0BC5-B93E-4653A371C2DE}"/>
              </a:ext>
            </a:extLst>
          </p:cNvPr>
          <p:cNvSpPr txBox="1"/>
          <p:nvPr/>
        </p:nvSpPr>
        <p:spPr>
          <a:xfrm>
            <a:off x="4360606" y="69153"/>
            <a:ext cx="6764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it-IT" sz="18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it-IT" dirty="0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402F37C6-A713-F056-DA5F-AA6FDAEE41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73676" y="987542"/>
            <a:ext cx="4340679" cy="30238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52137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64118AD-477C-E109-8803-BC36062DA102}"/>
              </a:ext>
            </a:extLst>
          </p:cNvPr>
          <p:cNvSpPr txBox="1"/>
          <p:nvPr/>
        </p:nvSpPr>
        <p:spPr>
          <a:xfrm>
            <a:off x="287101" y="5415594"/>
            <a:ext cx="856979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Folin-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ocalteu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ay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Poly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llic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ibration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ve. 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sorbance at 750 nm measured after Folin-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ocalteu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ssay performed on 30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μ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Poly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(</a:t>
            </a:r>
            <a:r>
              <a:rPr lang="it-IT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ibratio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v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btained using solutions at different concentrations of gallic acid (0-50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μg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ror bar indicates S.D.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asellaDiTesto 2">
            <a:extLst>
              <a:ext uri="{FF2B5EF4-FFF2-40B4-BE49-F238E27FC236}">
                <a16:creationId xmlns:a16="http://schemas.microsoft.com/office/drawing/2014/main" id="{6431C81D-E225-9923-8691-B364674A1D0D}"/>
              </a:ext>
            </a:extLst>
          </p:cNvPr>
          <p:cNvSpPr txBox="1"/>
          <p:nvPr/>
        </p:nvSpPr>
        <p:spPr>
          <a:xfrm>
            <a:off x="6106376" y="1246655"/>
            <a:ext cx="2177653" cy="4394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endParaRPr lang="it-IT" sz="1200" b="1" kern="12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r>
              <a:rPr lang="it-IT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r</a:t>
            </a:r>
            <a:r>
              <a:rPr lang="it-IT" sz="1200" b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it-IT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= 0.9924</a:t>
            </a:r>
          </a:p>
          <a:p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FA89C99-5B6D-8022-BE7A-6A558ACA176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87101" y="1381651"/>
          <a:ext cx="3316329" cy="33884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482245" imgH="2537369" progId="Prism10.Document">
                  <p:embed/>
                </p:oleObj>
              </mc:Choice>
              <mc:Fallback>
                <p:oleObj name="Prism 10" r:id="rId2" imgW="2482245" imgH="2537369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FA89C99-5B6D-8022-BE7A-6A558ACA17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87101" y="1381651"/>
                        <a:ext cx="3316329" cy="33884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F3968573-7A27-F48B-E8DB-81E0E15C6EA5}"/>
              </a:ext>
            </a:extLst>
          </p:cNvPr>
          <p:cNvSpPr txBox="1"/>
          <p:nvPr/>
        </p:nvSpPr>
        <p:spPr>
          <a:xfrm>
            <a:off x="287101" y="706615"/>
            <a:ext cx="6764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8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endParaRPr lang="it-IT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752F57D-1E2C-FFD6-36FD-155F301A47A2}"/>
              </a:ext>
            </a:extLst>
          </p:cNvPr>
          <p:cNvSpPr txBox="1"/>
          <p:nvPr/>
        </p:nvSpPr>
        <p:spPr>
          <a:xfrm>
            <a:off x="4057772" y="637462"/>
            <a:ext cx="6764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it-IT" sz="18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it-IT" dirty="0"/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3408F75F-BE92-6C0C-9F60-276AC98D59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3941570"/>
              </p:ext>
            </p:extLst>
          </p:nvPr>
        </p:nvGraphicFramePr>
        <p:xfrm>
          <a:off x="5763299" y="1072516"/>
          <a:ext cx="2063529" cy="325704"/>
        </p:xfrm>
        <a:graphic>
          <a:graphicData uri="http://schemas.openxmlformats.org/drawingml/2006/table">
            <a:tbl>
              <a:tblPr/>
              <a:tblGrid>
                <a:gridCol w="2063529">
                  <a:extLst>
                    <a:ext uri="{9D8B030D-6E8A-4147-A177-3AD203B41FA5}">
                      <a16:colId xmlns:a16="http://schemas.microsoft.com/office/drawing/2014/main" val="2428797449"/>
                    </a:ext>
                  </a:extLst>
                </a:gridCol>
              </a:tblGrid>
              <a:tr h="325704"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b="1" i="0" u="none" strike="noStrike" dirty="0">
                          <a:effectLst/>
                          <a:latin typeface="Arial" panose="020B0604020202020204" pitchFamily="34" charset="0"/>
                        </a:rPr>
                        <a:t>Y = 0.02663*X – 0.0254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0099761"/>
                  </a:ext>
                </a:extLst>
              </a:tr>
            </a:tbl>
          </a:graphicData>
        </a:graphic>
      </p:graphicFrame>
      <p:pic>
        <p:nvPicPr>
          <p:cNvPr id="14" name="Picture 13" descr="A graph of a number of objects&#10;&#10;AI-generated content may be incorrect.">
            <a:extLst>
              <a:ext uri="{FF2B5EF4-FFF2-40B4-BE49-F238E27FC236}">
                <a16:creationId xmlns:a16="http://schemas.microsoft.com/office/drawing/2014/main" id="{2146AE71-D849-B3C9-D957-6EED25FE471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018"/>
          <a:stretch/>
        </p:blipFill>
        <p:spPr>
          <a:xfrm>
            <a:off x="3820008" y="1791003"/>
            <a:ext cx="5036890" cy="3096683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78127571-9350-BB4B-1891-2E83B5D18576}"/>
              </a:ext>
            </a:extLst>
          </p:cNvPr>
          <p:cNvSpPr txBox="1"/>
          <p:nvPr/>
        </p:nvSpPr>
        <p:spPr>
          <a:xfrm>
            <a:off x="5649686" y="4930388"/>
            <a:ext cx="1868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Gallic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 Acid (</a:t>
            </a:r>
            <a:r>
              <a:rPr lang="it-IT" b="1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8681467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BF22852-5E21-D7CE-0F25-DA9B18C857E3}"/>
              </a:ext>
            </a:extLst>
          </p:cNvPr>
          <p:cNvSpPr txBox="1"/>
          <p:nvPr/>
        </p:nvSpPr>
        <p:spPr>
          <a:xfrm>
            <a:off x="424442" y="5443681"/>
            <a:ext cx="829511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 S1. 3D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focal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scopy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uPoly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 of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focal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scopy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med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uPoly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reen fluorescence signal (emission: 495-570 nm) was recorded using an excitation wavelength of 500 nm, while the blue fluorescence signal (emission 475-495 nm) with an excitation wavelength of 405 nm. 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video 3D modok">
            <a:hlinkClick r:id="" action="ppaction://media"/>
            <a:extLst>
              <a:ext uri="{FF2B5EF4-FFF2-40B4-BE49-F238E27FC236}">
                <a16:creationId xmlns:a16="http://schemas.microsoft.com/office/drawing/2014/main" id="{D1AA12C5-091E-9AB2-2892-68A339ADA79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bright="21000" contrast="34000"/>
          </a:blip>
          <a:stretch>
            <a:fillRect/>
          </a:stretch>
        </p:blipFill>
        <p:spPr>
          <a:xfrm>
            <a:off x="341143" y="382555"/>
            <a:ext cx="8461714" cy="47597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12567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0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222</Words>
  <Application>Microsoft Macintosh PowerPoint</Application>
  <PresentationFormat>Presentazione su schermo (4:3)</PresentationFormat>
  <Paragraphs>14</Paragraphs>
  <Slides>3</Slides>
  <Notes>0</Notes>
  <HiddenSlides>0</HiddenSlides>
  <MMClips>1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Office Theme</vt:lpstr>
      <vt:lpstr>Prism 10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ilvia Buonvino</dc:creator>
  <cp:lastModifiedBy>Microsoft Office User</cp:lastModifiedBy>
  <cp:revision>20</cp:revision>
  <dcterms:created xsi:type="dcterms:W3CDTF">2025-06-03T14:31:47Z</dcterms:created>
  <dcterms:modified xsi:type="dcterms:W3CDTF">2025-08-12T19:38:04Z</dcterms:modified>
</cp:coreProperties>
</file>